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6" d="100"/>
          <a:sy n="66" d="100"/>
        </p:scale>
        <p:origin x="33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11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807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9628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633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572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6015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55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4628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40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5329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06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060B7-2063-4A95-B3F7-EAA793614C7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39FE7-FA1A-4398-9DBB-D6998BE3F0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393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5133078"/>
              </p:ext>
            </p:extLst>
          </p:nvPr>
        </p:nvGraphicFramePr>
        <p:xfrm>
          <a:off x="377371" y="2842508"/>
          <a:ext cx="6049629" cy="786543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693756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21975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65481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4065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4065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3616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tle/Abstrac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eening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ll Text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eening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616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criteri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894534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design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studi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50 cas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studi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 cas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10 cases </a:t>
                      </a: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lang="en-GB" sz="8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lyburide </a:t>
                      </a: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iews, editorial comments, meeting abstracts, book chapter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peer review articles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 studi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gt;50 cas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ised controlled studies and prospective randomised controlled studi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studi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50 cases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iews, editorial comments, meeting abstracts, book chapters, non-peer review articl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88049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t women with GDM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2286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men with diagnosed GDM with singleton pregnancies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ese, non-diabetic pregnant women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clusion of participants based on fetal/birth weight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19271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sure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buride 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. insulin AND/OR diet</a:t>
                      </a: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buride</a:t>
                      </a:r>
                      <a:r>
                        <a:rPr lang="en-GB" sz="8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s. metformin AND/OR diet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228600"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ention given prior to pregnancy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pharmacological </a:t>
                      </a: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entions such as </a:t>
                      </a:r>
                      <a:r>
                        <a:rPr lang="en-GB" sz="8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</a:t>
                      </a:r>
                      <a:r>
                        <a:rPr lang="en-GB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inositol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                                                          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formin compared with insulin and/or diet therapy for women with GDM or untreated women with GDM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ention given only during pregnancy.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457200"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417449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‘Baseline’ maternal parameters recorded before study start and/or at follow-up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 weight and/or growth parameters of neonate recorded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cy and delivery complications recorded (e.g. gestational hypertension, pre-eclampsia and preterm birth) 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natal outcomes (including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glycemia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birth weight, SGA, LGA and body composition measurements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ldhood body composition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ldhood metabolic measures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ernal parameters recorded before study start and/or after study/follow-up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 weight and/or growth parameters of neonate recorded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gnancy and delivery complications recorded (e.g. gestational hypertension, pre-eclampsia and preterm birth)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natal outcomes recorded (including </a:t>
                      </a:r>
                      <a:r>
                        <a:rPr lang="en-GB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glycemia</a:t>
                      </a: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birth weight, SGA, LGA and body composition).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457200"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888" marR="64888" marT="0" marB="0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77371" y="1892204"/>
            <a:ext cx="2517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Table: Inclusion/Exclusion criteria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660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288</Words>
  <Application>Microsoft Office PowerPoint</Application>
  <PresentationFormat>Widescreen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 Adkins</cp:lastModifiedBy>
  <cp:revision>6</cp:revision>
  <cp:lastPrinted>2019-07-02T07:12:34Z</cp:lastPrinted>
  <dcterms:created xsi:type="dcterms:W3CDTF">2019-05-07T05:24:08Z</dcterms:created>
  <dcterms:modified xsi:type="dcterms:W3CDTF">2020-02-20T08:08:43Z</dcterms:modified>
</cp:coreProperties>
</file>